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12192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490" autoAdjust="0"/>
    <p:restoredTop sz="94660"/>
  </p:normalViewPr>
  <p:slideViewPr>
    <p:cSldViewPr snapToGrid="0">
      <p:cViewPr varScale="1">
        <p:scale>
          <a:sx n="53" d="100"/>
          <a:sy n="53" d="100"/>
        </p:scale>
        <p:origin x="-2192" y="-120"/>
      </p:cViewPr>
      <p:guideLst>
        <p:guide orient="horz" pos="384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4748F0-74FA-4F22-BC39-069594AC31B3}" type="datetimeFigureOut">
              <a:rPr lang="en-US" smtClean="0"/>
              <a:t>5/24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E82870-9E3B-4C96-A890-FD83F0FD3E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76715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4748F0-74FA-4F22-BC39-069594AC31B3}" type="datetimeFigureOut">
              <a:rPr lang="en-US" smtClean="0"/>
              <a:t>5/24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E82870-9E3B-4C96-A890-FD83F0FD3E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5601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4748F0-74FA-4F22-BC39-069594AC31B3}" type="datetimeFigureOut">
              <a:rPr lang="en-US" smtClean="0"/>
              <a:t>5/24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E82870-9E3B-4C96-A890-FD83F0FD3E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87382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4748F0-74FA-4F22-BC39-069594AC31B3}" type="datetimeFigureOut">
              <a:rPr lang="en-US" smtClean="0"/>
              <a:t>5/24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E82870-9E3B-4C96-A890-FD83F0FD3E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41658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4748F0-74FA-4F22-BC39-069594AC31B3}" type="datetimeFigureOut">
              <a:rPr lang="en-US" smtClean="0"/>
              <a:t>5/24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E82870-9E3B-4C96-A890-FD83F0FD3E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56553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4748F0-74FA-4F22-BC39-069594AC31B3}" type="datetimeFigureOut">
              <a:rPr lang="en-US" smtClean="0"/>
              <a:t>5/24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E82870-9E3B-4C96-A890-FD83F0FD3E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87729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4748F0-74FA-4F22-BC39-069594AC31B3}" type="datetimeFigureOut">
              <a:rPr lang="en-US" smtClean="0"/>
              <a:t>5/24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E82870-9E3B-4C96-A890-FD83F0FD3E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76363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4748F0-74FA-4F22-BC39-069594AC31B3}" type="datetimeFigureOut">
              <a:rPr lang="en-US" smtClean="0"/>
              <a:t>5/24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E82870-9E3B-4C96-A890-FD83F0FD3E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39149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4748F0-74FA-4F22-BC39-069594AC31B3}" type="datetimeFigureOut">
              <a:rPr lang="en-US" smtClean="0"/>
              <a:t>5/24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E82870-9E3B-4C96-A890-FD83F0FD3E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47688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4748F0-74FA-4F22-BC39-069594AC31B3}" type="datetimeFigureOut">
              <a:rPr lang="en-US" smtClean="0"/>
              <a:t>5/24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E82870-9E3B-4C96-A890-FD83F0FD3E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24333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4748F0-74FA-4F22-BC39-069594AC31B3}" type="datetimeFigureOut">
              <a:rPr lang="en-US" smtClean="0"/>
              <a:t>5/24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E82870-9E3B-4C96-A890-FD83F0FD3E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8611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4748F0-74FA-4F22-BC39-069594AC31B3}" type="datetimeFigureOut">
              <a:rPr lang="en-US" smtClean="0"/>
              <a:t>5/24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E82870-9E3B-4C96-A890-FD83F0FD3E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63638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5317936"/>
              </p:ext>
            </p:extLst>
          </p:nvPr>
        </p:nvGraphicFramePr>
        <p:xfrm>
          <a:off x="60960" y="2981678"/>
          <a:ext cx="6736080" cy="4065239"/>
        </p:xfrm>
        <a:graphic>
          <a:graphicData uri="http://schemas.openxmlformats.org/drawingml/2006/table">
            <a:tbl>
              <a:tblPr firstRow="1" firstCol="1" bandRow="1"/>
              <a:tblGrid>
                <a:gridCol w="1807609"/>
                <a:gridCol w="726473"/>
                <a:gridCol w="630279"/>
                <a:gridCol w="722290"/>
                <a:gridCol w="678376"/>
                <a:gridCol w="651191"/>
                <a:gridCol w="797572"/>
                <a:gridCol w="722290"/>
              </a:tblGrid>
              <a:tr h="406524"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 b="1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roperty</a:t>
                      </a:r>
                      <a:endParaRPr lang="en-US" sz="16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338" marR="90338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torva</a:t>
                      </a:r>
                      <a:endParaRPr lang="en-US" sz="16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338" marR="90338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 b="1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luva</a:t>
                      </a:r>
                      <a:endParaRPr lang="en-US" sz="16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338" marR="90338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Lova</a:t>
                      </a:r>
                      <a:endParaRPr lang="en-US" sz="16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338" marR="90338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itava</a:t>
                      </a:r>
                      <a:endParaRPr lang="en-US" sz="16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338" marR="90338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rava</a:t>
                      </a:r>
                      <a:endParaRPr lang="en-US" sz="16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338" marR="90338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Rosuva</a:t>
                      </a:r>
                      <a:endParaRPr lang="en-US" sz="16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338" marR="90338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imva</a:t>
                      </a:r>
                      <a:endParaRPr lang="en-US" sz="16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338" marR="90338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06524"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Log D</a:t>
                      </a:r>
                      <a:endParaRPr lang="en-US" sz="16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338" marR="90338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.11</a:t>
                      </a:r>
                      <a:endParaRPr lang="en-US" sz="16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338" marR="90338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.27</a:t>
                      </a:r>
                      <a:endParaRPr lang="en-US" sz="16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338" marR="90338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.7</a:t>
                      </a:r>
                      <a:endParaRPr lang="en-US" sz="16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338" marR="90338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.49</a:t>
                      </a:r>
                      <a:endParaRPr lang="en-US" sz="16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338" marR="90338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0.84</a:t>
                      </a:r>
                      <a:endParaRPr lang="en-US" sz="16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338" marR="90338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0.33</a:t>
                      </a:r>
                      <a:endParaRPr lang="en-US" sz="16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338" marR="90338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.60</a:t>
                      </a:r>
                      <a:endParaRPr lang="en-US" sz="16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338" marR="90338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</a:tr>
              <a:tr h="406524"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ioavailability (%)</a:t>
                      </a:r>
                      <a:endParaRPr lang="en-US" sz="16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338" marR="9033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4</a:t>
                      </a:r>
                      <a:endParaRPr lang="en-US" sz="16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338" marR="9033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4</a:t>
                      </a:r>
                      <a:endParaRPr lang="en-US" sz="16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338" marR="9033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&lt;5</a:t>
                      </a:r>
                      <a:endParaRPr lang="en-US" sz="16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338" marR="9033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1</a:t>
                      </a:r>
                      <a:endParaRPr lang="en-US" sz="16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338" marR="9033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7</a:t>
                      </a:r>
                      <a:endParaRPr lang="en-US" sz="16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338" marR="9033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0</a:t>
                      </a:r>
                      <a:endParaRPr lang="en-US" sz="16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338" marR="9033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&lt;5</a:t>
                      </a:r>
                      <a:endParaRPr lang="en-US" sz="16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338" marR="9033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406524"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</a:t>
                      </a:r>
                      <a:r>
                        <a:rPr lang="en-US" sz="1300" b="1" baseline="-25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ax</a:t>
                      </a:r>
                      <a:r>
                        <a:rPr lang="en-US" sz="13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(h)</a:t>
                      </a:r>
                      <a:endParaRPr lang="en-US" sz="16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338" marR="9033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-2</a:t>
                      </a:r>
                      <a:endParaRPr lang="en-US" sz="16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338" marR="9033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&lt;1</a:t>
                      </a:r>
                      <a:endParaRPr lang="en-US" sz="16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338" marR="9033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-4</a:t>
                      </a:r>
                      <a:endParaRPr lang="en-US" sz="16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338" marR="9033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US" sz="16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338" marR="9033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-1.5</a:t>
                      </a:r>
                      <a:endParaRPr lang="en-US" sz="16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338" marR="9033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-5</a:t>
                      </a:r>
                      <a:endParaRPr lang="en-US" sz="16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338" marR="9033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endParaRPr lang="en-US" sz="16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338" marR="9033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</a:tr>
              <a:tr h="406524"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rotein Binding (%)</a:t>
                      </a:r>
                      <a:endParaRPr lang="en-US" sz="16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338" marR="9033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&gt; 98</a:t>
                      </a:r>
                      <a:endParaRPr lang="en-US" sz="16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338" marR="9033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98</a:t>
                      </a:r>
                      <a:endParaRPr lang="en-US" sz="16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338" marR="9033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&gt;95</a:t>
                      </a:r>
                      <a:endParaRPr lang="en-US" sz="16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338" marR="9033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99</a:t>
                      </a:r>
                      <a:endParaRPr lang="en-US" sz="16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338" marR="9033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0</a:t>
                      </a:r>
                      <a:endParaRPr lang="en-US" sz="16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338" marR="9033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88</a:t>
                      </a:r>
                      <a:endParaRPr lang="en-US" sz="16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338" marR="9033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95</a:t>
                      </a:r>
                      <a:endParaRPr lang="en-US" sz="16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338" marR="9033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13047"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YP450 Isozyme</a:t>
                      </a:r>
                      <a:endParaRPr lang="en-US" sz="16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338" marR="9033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A4</a:t>
                      </a:r>
                      <a:endParaRPr lang="en-US" sz="16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338" marR="9033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C9</a:t>
                      </a:r>
                      <a:endParaRPr lang="en-US" sz="16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338" marR="9033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A4</a:t>
                      </a:r>
                      <a:endParaRPr lang="en-US" sz="16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338" marR="9033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C9</a:t>
                      </a:r>
                      <a:endParaRPr lang="en-US" sz="16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indent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C8</a:t>
                      </a:r>
                      <a:endParaRPr lang="en-US" sz="16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338" marR="9033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one</a:t>
                      </a:r>
                      <a:endParaRPr lang="en-US" sz="16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338" marR="9033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C9</a:t>
                      </a:r>
                      <a:endParaRPr lang="en-US" sz="16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338" marR="9033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A4</a:t>
                      </a:r>
                      <a:endParaRPr lang="en-US" sz="16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338" marR="9033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</a:tr>
              <a:tr h="406524"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ctive Metabolites (n)</a:t>
                      </a:r>
                      <a:endParaRPr lang="en-US" sz="16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338" marR="9033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Yes (2)</a:t>
                      </a:r>
                      <a:endParaRPr lang="en-US" sz="16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338" marR="9033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o</a:t>
                      </a:r>
                      <a:endParaRPr lang="en-US" sz="16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338" marR="9033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Yes (4)</a:t>
                      </a:r>
                      <a:endParaRPr lang="en-US" sz="16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338" marR="9033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o</a:t>
                      </a:r>
                      <a:endParaRPr lang="en-US" sz="16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338" marR="9033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o</a:t>
                      </a:r>
                      <a:endParaRPr lang="en-US" sz="16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338" marR="9033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inimal</a:t>
                      </a:r>
                      <a:endParaRPr lang="en-US" sz="16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338" marR="9033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Yes (3)</a:t>
                      </a:r>
                      <a:endParaRPr lang="en-US" sz="16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338" marR="9033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406524"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Elimination T</a:t>
                      </a:r>
                      <a:r>
                        <a:rPr lang="en-US" sz="1300" b="1" baseline="-25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/2</a:t>
                      </a:r>
                      <a:r>
                        <a:rPr lang="en-US" sz="13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(h)</a:t>
                      </a:r>
                      <a:endParaRPr lang="en-US" sz="16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338" marR="9033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4</a:t>
                      </a:r>
                      <a:endParaRPr lang="en-US" sz="16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338" marR="9033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.2</a:t>
                      </a:r>
                      <a:endParaRPr lang="en-US" sz="16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338" marR="9033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</a:t>
                      </a:r>
                      <a:endParaRPr lang="en-US" sz="16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338" marR="9033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1</a:t>
                      </a:r>
                      <a:endParaRPr lang="en-US" sz="16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338" marR="9033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.8</a:t>
                      </a:r>
                      <a:endParaRPr lang="en-US" sz="16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338" marR="9033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9</a:t>
                      </a:r>
                      <a:endParaRPr lang="en-US" sz="16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338" marR="9033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US" sz="16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338" marR="9033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</a:tr>
              <a:tr h="406524"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Renal Excretion (%)</a:t>
                      </a:r>
                      <a:endParaRPr lang="en-US" sz="16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338" marR="9033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&lt;2</a:t>
                      </a:r>
                      <a:endParaRPr lang="en-US" sz="16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338" marR="9033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&lt;6</a:t>
                      </a:r>
                      <a:endParaRPr lang="en-US" sz="16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338" marR="9033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0</a:t>
                      </a:r>
                      <a:endParaRPr lang="en-US" sz="16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338" marR="9033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5</a:t>
                      </a:r>
                      <a:endParaRPr lang="en-US" sz="16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338" marR="9033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0</a:t>
                      </a:r>
                      <a:endParaRPr lang="en-US" sz="16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338" marR="9033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0</a:t>
                      </a:r>
                      <a:endParaRPr lang="en-US" sz="16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338" marR="9033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3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3</a:t>
                      </a:r>
                      <a:endParaRPr lang="en-US" sz="16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338" marR="9033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389944" y="8422066"/>
            <a:ext cx="6198527" cy="31393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Additional File 3.pptx: Pharmacokinetic properties of the seven FDA approved statins. </a:t>
            </a:r>
            <a:r>
              <a:rPr lang="en-US" dirty="0"/>
              <a:t>Absorption, distribution, metabolism, and excretion parameters for each statin are listed. The statin prefixes are used instead of the whole name (e.g. </a:t>
            </a:r>
            <a:r>
              <a:rPr lang="en-US" dirty="0" err="1"/>
              <a:t>Atorva</a:t>
            </a:r>
            <a:r>
              <a:rPr lang="en-US" dirty="0"/>
              <a:t> = Atorvastatin). Times are represented in hours (h). Log D = distribution coefficient at pH 7.4 (higher value means more lipophilic); </a:t>
            </a:r>
            <a:r>
              <a:rPr lang="en-US" dirty="0" err="1"/>
              <a:t>T</a:t>
            </a:r>
            <a:r>
              <a:rPr lang="en-US" baseline="-25000" dirty="0" err="1"/>
              <a:t>max</a:t>
            </a:r>
            <a:r>
              <a:rPr lang="en-US" dirty="0"/>
              <a:t> = time after oral dose to maximum serum concentration; CYP450 = cytochrome P450; T</a:t>
            </a:r>
            <a:r>
              <a:rPr lang="en-US" baseline="-25000" dirty="0"/>
              <a:t>1/2</a:t>
            </a:r>
            <a:r>
              <a:rPr lang="en-US" dirty="0"/>
              <a:t> = half-life. Data were acquired from </a:t>
            </a:r>
            <a:r>
              <a:rPr lang="en-US" dirty="0" err="1"/>
              <a:t>Schachter</a:t>
            </a:r>
            <a:r>
              <a:rPr lang="en-US" dirty="0"/>
              <a:t> 2005</a:t>
            </a:r>
            <a:r>
              <a:rPr lang="en-US" baseline="30000" dirty="0"/>
              <a:t>8</a:t>
            </a:r>
            <a:r>
              <a:rPr lang="en-US" dirty="0"/>
              <a:t>, </a:t>
            </a:r>
            <a:r>
              <a:rPr lang="en-US" dirty="0" err="1"/>
              <a:t>McKenney</a:t>
            </a:r>
            <a:r>
              <a:rPr lang="en-US" dirty="0"/>
              <a:t> et al 2009</a:t>
            </a:r>
            <a:r>
              <a:rPr lang="en-US" baseline="30000" dirty="0"/>
              <a:t>15</a:t>
            </a:r>
            <a:r>
              <a:rPr lang="en-US" dirty="0"/>
              <a:t>, and Davidson et al 2006</a:t>
            </a:r>
            <a:r>
              <a:rPr lang="en-US" baseline="30000" dirty="0"/>
              <a:t>203</a:t>
            </a:r>
            <a:r>
              <a:rPr lang="en-US" dirty="0"/>
              <a:t>.</a:t>
            </a:r>
            <a:endParaRPr lang="en-US" b="1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812437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</TotalTime>
  <Words>240</Words>
  <Application>Microsoft Macintosh PowerPoint</Application>
  <PresentationFormat>Custom</PresentationFormat>
  <Paragraphs>7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olin Beckwitt</dc:creator>
  <cp:lastModifiedBy>Alan Wells</cp:lastModifiedBy>
  <cp:revision>9</cp:revision>
  <dcterms:created xsi:type="dcterms:W3CDTF">2018-05-04T13:31:49Z</dcterms:created>
  <dcterms:modified xsi:type="dcterms:W3CDTF">2018-05-24T18:31:29Z</dcterms:modified>
</cp:coreProperties>
</file>